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 showGuides="1">
      <p:cViewPr>
        <p:scale>
          <a:sx n="55" d="100"/>
          <a:sy n="55" d="100"/>
        </p:scale>
        <p:origin x="2549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7AF22B-346C-4E4C-A24D-79F29F28799A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DEC100-F7E7-4947-A422-9D059C4154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65598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DEC100-F7E7-4947-A422-9D059C4154CA}" type="slidenum">
              <a:rPr lang="ru-RU" smtClean="0"/>
              <a:t>1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905289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07545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7783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79227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68116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70279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35068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81498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60183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31918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63892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86232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787C8-DB73-424B-8AAD-39C4E6B0E4DB}" type="datetimeFigureOut">
              <a:rPr lang="ru-RU" smtClean="0"/>
              <a:t>03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33806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8" name="Группа 147">
            <a:extLst>
              <a:ext uri="{FF2B5EF4-FFF2-40B4-BE49-F238E27FC236}">
                <a16:creationId xmlns:a16="http://schemas.microsoft.com/office/drawing/2014/main" id="{B5474DD2-E797-5EE2-18FF-FA3383C81AFB}"/>
              </a:ext>
            </a:extLst>
          </p:cNvPr>
          <p:cNvGrpSpPr/>
          <p:nvPr/>
        </p:nvGrpSpPr>
        <p:grpSpPr>
          <a:xfrm>
            <a:off x="0" y="0"/>
            <a:ext cx="6432669" cy="9924305"/>
            <a:chOff x="0" y="0"/>
            <a:chExt cx="6432669" cy="9924305"/>
          </a:xfrm>
        </p:grpSpPr>
        <p:grpSp>
          <p:nvGrpSpPr>
            <p:cNvPr id="4" name="Группа 3">
              <a:extLst>
                <a:ext uri="{FF2B5EF4-FFF2-40B4-BE49-F238E27FC236}">
                  <a16:creationId xmlns:a16="http://schemas.microsoft.com/office/drawing/2014/main" id="{3CA4CE84-EF4B-D474-0473-B4E939962A67}"/>
                </a:ext>
              </a:extLst>
            </p:cNvPr>
            <p:cNvGrpSpPr/>
            <p:nvPr/>
          </p:nvGrpSpPr>
          <p:grpSpPr>
            <a:xfrm>
              <a:off x="0" y="0"/>
              <a:ext cx="4791566" cy="2247657"/>
              <a:chOff x="7391" y="-50464"/>
              <a:chExt cx="4791566" cy="2247657"/>
            </a:xfrm>
          </p:grpSpPr>
          <p:pic>
            <p:nvPicPr>
              <p:cNvPr id="5" name="Рисунок 4">
                <a:extLst>
                  <a:ext uri="{FF2B5EF4-FFF2-40B4-BE49-F238E27FC236}">
                    <a16:creationId xmlns:a16="http://schemas.microsoft.com/office/drawing/2014/main" id="{9E229E0D-C520-5BA1-4B19-A71F02614D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71" t="5915" r="27026" b="12951"/>
              <a:stretch/>
            </p:blipFill>
            <p:spPr>
              <a:xfrm>
                <a:off x="397878" y="228600"/>
                <a:ext cx="1795139" cy="1715947"/>
              </a:xfrm>
              <a:prstGeom prst="rect">
                <a:avLst/>
              </a:prstGeom>
            </p:spPr>
          </p:pic>
          <p:pic>
            <p:nvPicPr>
              <p:cNvPr id="6" name="Рисунок 5">
                <a:extLst>
                  <a:ext uri="{FF2B5EF4-FFF2-40B4-BE49-F238E27FC236}">
                    <a16:creationId xmlns:a16="http://schemas.microsoft.com/office/drawing/2014/main" id="{F285B3F1-418D-B50C-71D1-BB48A7E913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86" t="5915" b="12951"/>
              <a:stretch/>
            </p:blipFill>
            <p:spPr>
              <a:xfrm>
                <a:off x="2339830" y="228600"/>
                <a:ext cx="2439338" cy="1715947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CCBB7A6-BEFC-0C70-262E-47638A007C0D}"/>
                  </a:ext>
                </a:extLst>
              </p:cNvPr>
              <p:cNvSpPr txBox="1"/>
              <p:nvPr/>
            </p:nvSpPr>
            <p:spPr>
              <a:xfrm>
                <a:off x="686196" y="0"/>
                <a:ext cx="12041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With centrifugation</a:t>
                </a:r>
                <a:endParaRPr lang="ru-RU" sz="1000" dirty="0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D8E2C0F-3376-FF3A-6DEB-F431D61721FE}"/>
                  </a:ext>
                </a:extLst>
              </p:cNvPr>
              <p:cNvSpPr txBox="1"/>
              <p:nvPr/>
            </p:nvSpPr>
            <p:spPr>
              <a:xfrm>
                <a:off x="2521591" y="415"/>
                <a:ext cx="13821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70C0"/>
                    </a:solidFill>
                  </a:rPr>
                  <a:t>Without centrifugation</a:t>
                </a:r>
                <a:endParaRPr lang="ru-RU" sz="1000" dirty="0">
                  <a:solidFill>
                    <a:srgbClr val="0070C0"/>
                  </a:solidFill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EC5CA84-D023-4166-6B88-0199A397D293}"/>
                  </a:ext>
                </a:extLst>
              </p:cNvPr>
              <p:cNvSpPr txBox="1"/>
              <p:nvPr/>
            </p:nvSpPr>
            <p:spPr>
              <a:xfrm>
                <a:off x="7391" y="-50464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A</a:t>
                </a:r>
                <a:endParaRPr lang="ru-RU" dirty="0"/>
              </a:p>
            </p:txBody>
          </p:sp>
          <p:sp>
            <p:nvSpPr>
              <p:cNvPr id="10" name="Прямоугольник 9">
                <a:extLst>
                  <a:ext uri="{FF2B5EF4-FFF2-40B4-BE49-F238E27FC236}">
                    <a16:creationId xmlns:a16="http://schemas.microsoft.com/office/drawing/2014/main" id="{ED2531B3-202A-E7EC-EAFA-EEF75760224E}"/>
                  </a:ext>
                </a:extLst>
              </p:cNvPr>
              <p:cNvSpPr/>
              <p:nvPr/>
            </p:nvSpPr>
            <p:spPr>
              <a:xfrm>
                <a:off x="4073727" y="278753"/>
                <a:ext cx="609049" cy="2990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grpSp>
            <p:nvGrpSpPr>
              <p:cNvPr id="11" name="Группа 10">
                <a:extLst>
                  <a:ext uri="{FF2B5EF4-FFF2-40B4-BE49-F238E27FC236}">
                    <a16:creationId xmlns:a16="http://schemas.microsoft.com/office/drawing/2014/main" id="{4604FF3A-DAD1-319C-6E0C-324B180ED5CE}"/>
                  </a:ext>
                </a:extLst>
              </p:cNvPr>
              <p:cNvGrpSpPr/>
              <p:nvPr/>
            </p:nvGrpSpPr>
            <p:grpSpPr>
              <a:xfrm>
                <a:off x="4076458" y="207119"/>
                <a:ext cx="722499" cy="711282"/>
                <a:chOff x="4111699" y="576276"/>
                <a:chExt cx="722499" cy="711282"/>
              </a:xfrm>
            </p:grpSpPr>
            <p:sp>
              <p:nvSpPr>
                <p:cNvPr id="29" name="Прямоугольник 28">
                  <a:extLst>
                    <a:ext uri="{FF2B5EF4-FFF2-40B4-BE49-F238E27FC236}">
                      <a16:creationId xmlns:a16="http://schemas.microsoft.com/office/drawing/2014/main" id="{6FDEE1EB-CBCB-FBBC-1E0C-8DD887A34070}"/>
                    </a:ext>
                  </a:extLst>
                </p:cNvPr>
                <p:cNvSpPr/>
                <p:nvPr/>
              </p:nvSpPr>
              <p:spPr>
                <a:xfrm>
                  <a:off x="4111699" y="630844"/>
                  <a:ext cx="116652" cy="105363"/>
                </a:xfrm>
                <a:prstGeom prst="rect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0" name="Прямоугольник 29">
                  <a:extLst>
                    <a:ext uri="{FF2B5EF4-FFF2-40B4-BE49-F238E27FC236}">
                      <a16:creationId xmlns:a16="http://schemas.microsoft.com/office/drawing/2014/main" id="{278AA6A8-5013-99FD-380A-2FD80A1B144F}"/>
                    </a:ext>
                  </a:extLst>
                </p:cNvPr>
                <p:cNvSpPr/>
                <p:nvPr/>
              </p:nvSpPr>
              <p:spPr>
                <a:xfrm>
                  <a:off x="4111699" y="798768"/>
                  <a:ext cx="116652" cy="105363"/>
                </a:xfrm>
                <a:prstGeom prst="rect">
                  <a:avLst/>
                </a:prstGeom>
                <a:solidFill>
                  <a:srgbClr val="EFB789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1" name="Прямоугольник 30">
                  <a:extLst>
                    <a:ext uri="{FF2B5EF4-FFF2-40B4-BE49-F238E27FC236}">
                      <a16:creationId xmlns:a16="http://schemas.microsoft.com/office/drawing/2014/main" id="{92E6908D-9CAF-51B2-1A3C-B4B8DC00FE4A}"/>
                    </a:ext>
                  </a:extLst>
                </p:cNvPr>
                <p:cNvSpPr/>
                <p:nvPr/>
              </p:nvSpPr>
              <p:spPr>
                <a:xfrm>
                  <a:off x="4111699" y="964392"/>
                  <a:ext cx="116652" cy="105363"/>
                </a:xfrm>
                <a:prstGeom prst="rect">
                  <a:avLst/>
                </a:prstGeom>
                <a:solidFill>
                  <a:srgbClr val="97F4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2" name="Прямоугольник 31">
                  <a:extLst>
                    <a:ext uri="{FF2B5EF4-FFF2-40B4-BE49-F238E27FC236}">
                      <a16:creationId xmlns:a16="http://schemas.microsoft.com/office/drawing/2014/main" id="{17B69076-0A49-53F7-CBB8-69FBBD6BB057}"/>
                    </a:ext>
                  </a:extLst>
                </p:cNvPr>
                <p:cNvSpPr/>
                <p:nvPr/>
              </p:nvSpPr>
              <p:spPr>
                <a:xfrm>
                  <a:off x="4111699" y="1127656"/>
                  <a:ext cx="116652" cy="105363"/>
                </a:xfrm>
                <a:prstGeom prst="rect">
                  <a:avLst/>
                </a:prstGeom>
                <a:solidFill>
                  <a:schemeClr val="accent6">
                    <a:lumMod val="75000"/>
                  </a:scheme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A4CA55EC-B6F2-DE0D-35CF-CC4611CF3605}"/>
                    </a:ext>
                  </a:extLst>
                </p:cNvPr>
                <p:cNvSpPr txBox="1"/>
                <p:nvPr/>
              </p:nvSpPr>
              <p:spPr>
                <a:xfrm>
                  <a:off x="4187868" y="576276"/>
                  <a:ext cx="63991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unmapped</a:t>
                  </a:r>
                  <a:endParaRPr lang="ru-RU" sz="800" dirty="0"/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E25CF186-2FC0-A55F-FC11-1C23FC6D8BB7}"/>
                    </a:ext>
                  </a:extLst>
                </p:cNvPr>
                <p:cNvSpPr txBox="1"/>
                <p:nvPr/>
              </p:nvSpPr>
              <p:spPr>
                <a:xfrm>
                  <a:off x="4187867" y="748948"/>
                  <a:ext cx="6463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ambiguous</a:t>
                  </a:r>
                  <a:endParaRPr lang="ru-RU" sz="800" dirty="0"/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02864DCB-8AA6-B088-E210-587AED747EE6}"/>
                    </a:ext>
                  </a:extLst>
                </p:cNvPr>
                <p:cNvSpPr txBox="1"/>
                <p:nvPr/>
              </p:nvSpPr>
              <p:spPr>
                <a:xfrm>
                  <a:off x="4187867" y="912212"/>
                  <a:ext cx="62709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noncoding</a:t>
                  </a:r>
                  <a:endParaRPr lang="ru-RU" sz="800" dirty="0"/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70E37D55-A5E9-FC13-77E4-E7EA635CB57D}"/>
                    </a:ext>
                  </a:extLst>
                </p:cNvPr>
                <p:cNvSpPr txBox="1"/>
                <p:nvPr/>
              </p:nvSpPr>
              <p:spPr>
                <a:xfrm>
                  <a:off x="4186828" y="1072114"/>
                  <a:ext cx="46358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coding</a:t>
                  </a:r>
                  <a:endParaRPr lang="ru-RU" sz="800" dirty="0"/>
                </a:p>
              </p:txBody>
            </p:sp>
          </p:grp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5C57455-9F80-D371-567E-F453E38DA0CB}"/>
                  </a:ext>
                </a:extLst>
              </p:cNvPr>
              <p:cNvSpPr txBox="1"/>
              <p:nvPr/>
            </p:nvSpPr>
            <p:spPr>
              <a:xfrm rot="16200000">
                <a:off x="-56416" y="978851"/>
                <a:ext cx="50847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percent</a:t>
                </a:r>
                <a:endParaRPr lang="ru-RU" sz="800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A8DEAE8-44A3-5B6A-E77D-73D8961D9AE0}"/>
                  </a:ext>
                </a:extLst>
              </p:cNvPr>
              <p:cNvSpPr txBox="1"/>
              <p:nvPr/>
            </p:nvSpPr>
            <p:spPr>
              <a:xfrm>
                <a:off x="191702" y="1499480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0</a:t>
                </a:r>
                <a:endParaRPr lang="ru-RU" sz="800" dirty="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A9F77A3-5CE3-DD4B-DAA9-EA1F389F6BBA}"/>
                  </a:ext>
                </a:extLst>
              </p:cNvPr>
              <p:cNvSpPr txBox="1"/>
              <p:nvPr/>
            </p:nvSpPr>
            <p:spPr>
              <a:xfrm>
                <a:off x="189834" y="1179554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40</a:t>
                </a:r>
                <a:endParaRPr lang="ru-RU" sz="800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C59007D7-7F64-3560-C206-B0DB011A244D}"/>
                  </a:ext>
                </a:extLst>
              </p:cNvPr>
              <p:cNvSpPr txBox="1"/>
              <p:nvPr/>
            </p:nvSpPr>
            <p:spPr>
              <a:xfrm>
                <a:off x="189834" y="857904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60</a:t>
                </a:r>
                <a:endParaRPr lang="ru-RU" sz="800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18C193F-AD49-1E39-59CF-E016724446A1}"/>
                  </a:ext>
                </a:extLst>
              </p:cNvPr>
              <p:cNvSpPr txBox="1"/>
              <p:nvPr/>
            </p:nvSpPr>
            <p:spPr>
              <a:xfrm>
                <a:off x="187552" y="51154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80</a:t>
                </a:r>
                <a:endParaRPr lang="ru-RU" sz="800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4D86362-8070-29AD-B0F1-3413A38637E7}"/>
                  </a:ext>
                </a:extLst>
              </p:cNvPr>
              <p:cNvSpPr txBox="1"/>
              <p:nvPr/>
            </p:nvSpPr>
            <p:spPr>
              <a:xfrm>
                <a:off x="151092" y="201063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00</a:t>
                </a:r>
                <a:endParaRPr lang="ru-RU" sz="800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3C444D3-DBB6-0CB6-2CF5-C0D970F931FC}"/>
                  </a:ext>
                </a:extLst>
              </p:cNvPr>
              <p:cNvSpPr txBox="1"/>
              <p:nvPr/>
            </p:nvSpPr>
            <p:spPr>
              <a:xfrm>
                <a:off x="562286" y="1944547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rep1</a:t>
                </a:r>
                <a:endParaRPr lang="ru-RU" sz="1000" dirty="0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499BA62-A6C0-6B3D-7D29-4063E939AA8F}"/>
                  </a:ext>
                </a:extLst>
              </p:cNvPr>
              <p:cNvSpPr txBox="1"/>
              <p:nvPr/>
            </p:nvSpPr>
            <p:spPr>
              <a:xfrm>
                <a:off x="1080786" y="1944547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rep2</a:t>
                </a:r>
                <a:endParaRPr lang="ru-RU" sz="1000" dirty="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0A98BE5F-49E9-72E6-15BA-690B94AA218B}"/>
                  </a:ext>
                </a:extLst>
              </p:cNvPr>
              <p:cNvSpPr txBox="1"/>
              <p:nvPr/>
            </p:nvSpPr>
            <p:spPr>
              <a:xfrm>
                <a:off x="1626227" y="1950972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rep3</a:t>
                </a:r>
                <a:endParaRPr lang="ru-RU" sz="1000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E040355-6699-61E2-119A-4CCB025049A8}"/>
                  </a:ext>
                </a:extLst>
              </p:cNvPr>
              <p:cNvSpPr txBox="1"/>
              <p:nvPr/>
            </p:nvSpPr>
            <p:spPr>
              <a:xfrm>
                <a:off x="2481512" y="1927042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rep1</a:t>
                </a:r>
                <a:endParaRPr lang="ru-RU" sz="1000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16ACFD6-85BE-19E5-7DB6-24E5A16F4E19}"/>
                  </a:ext>
                </a:extLst>
              </p:cNvPr>
              <p:cNvSpPr txBox="1"/>
              <p:nvPr/>
            </p:nvSpPr>
            <p:spPr>
              <a:xfrm>
                <a:off x="3000012" y="1927042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rep2</a:t>
                </a:r>
                <a:endParaRPr lang="ru-RU" sz="1000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55A61FC2-A7F9-EEF6-9C08-31D3793E6E46}"/>
                  </a:ext>
                </a:extLst>
              </p:cNvPr>
              <p:cNvSpPr txBox="1"/>
              <p:nvPr/>
            </p:nvSpPr>
            <p:spPr>
              <a:xfrm>
                <a:off x="3545453" y="1933467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rep3</a:t>
                </a:r>
                <a:endParaRPr lang="ru-RU" sz="1000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4DDB1A5-A6D1-9E6B-E39C-649E835BD44A}"/>
                  </a:ext>
                </a:extLst>
              </p:cNvPr>
              <p:cNvSpPr txBox="1"/>
              <p:nvPr/>
            </p:nvSpPr>
            <p:spPr>
              <a:xfrm>
                <a:off x="2125726" y="1499480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0</a:t>
                </a:r>
                <a:endParaRPr lang="ru-RU" sz="800" dirty="0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6F76F40-52E0-591C-30D3-432D9961E869}"/>
                  </a:ext>
                </a:extLst>
              </p:cNvPr>
              <p:cNvSpPr txBox="1"/>
              <p:nvPr/>
            </p:nvSpPr>
            <p:spPr>
              <a:xfrm>
                <a:off x="2123858" y="1179554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40</a:t>
                </a:r>
                <a:endParaRPr lang="ru-RU" sz="800" dirty="0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1949973E-7914-C713-93EE-36544C35BAF4}"/>
                  </a:ext>
                </a:extLst>
              </p:cNvPr>
              <p:cNvSpPr txBox="1"/>
              <p:nvPr/>
            </p:nvSpPr>
            <p:spPr>
              <a:xfrm>
                <a:off x="2123858" y="857904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60</a:t>
                </a:r>
                <a:endParaRPr lang="ru-RU" sz="800" dirty="0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BAC24393-00D8-6FA4-7F1F-83BE47E58136}"/>
                  </a:ext>
                </a:extLst>
              </p:cNvPr>
              <p:cNvSpPr txBox="1"/>
              <p:nvPr/>
            </p:nvSpPr>
            <p:spPr>
              <a:xfrm>
                <a:off x="2121576" y="51154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80</a:t>
                </a:r>
                <a:endParaRPr lang="ru-RU" sz="8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A25C0D4F-58FF-76C4-5FC5-51DFA7019782}"/>
                  </a:ext>
                </a:extLst>
              </p:cNvPr>
              <p:cNvSpPr txBox="1"/>
              <p:nvPr/>
            </p:nvSpPr>
            <p:spPr>
              <a:xfrm>
                <a:off x="2085116" y="201063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00</a:t>
                </a:r>
                <a:endParaRPr lang="ru-RU" sz="800" dirty="0"/>
              </a:p>
            </p:txBody>
          </p:sp>
        </p:grpSp>
        <p:grpSp>
          <p:nvGrpSpPr>
            <p:cNvPr id="37" name="Группа 36">
              <a:extLst>
                <a:ext uri="{FF2B5EF4-FFF2-40B4-BE49-F238E27FC236}">
                  <a16:creationId xmlns:a16="http://schemas.microsoft.com/office/drawing/2014/main" id="{B75283F8-7F2C-B4D4-5020-B2FA8EB73097}"/>
                </a:ext>
              </a:extLst>
            </p:cNvPr>
            <p:cNvGrpSpPr/>
            <p:nvPr/>
          </p:nvGrpSpPr>
          <p:grpSpPr>
            <a:xfrm>
              <a:off x="0" y="2164731"/>
              <a:ext cx="4669560" cy="2022343"/>
              <a:chOff x="30976" y="2477331"/>
              <a:chExt cx="4669560" cy="2022343"/>
            </a:xfrm>
          </p:grpSpPr>
          <p:pic>
            <p:nvPicPr>
              <p:cNvPr id="38" name="Рисунок 37">
                <a:extLst>
                  <a:ext uri="{FF2B5EF4-FFF2-40B4-BE49-F238E27FC236}">
                    <a16:creationId xmlns:a16="http://schemas.microsoft.com/office/drawing/2014/main" id="{F48D9729-3CCA-988F-1D80-BBF6C99D55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05" t="8080" r="6081" b="5912"/>
              <a:stretch/>
            </p:blipFill>
            <p:spPr>
              <a:xfrm>
                <a:off x="424800" y="2728968"/>
                <a:ext cx="1730190" cy="1508423"/>
              </a:xfrm>
              <a:prstGeom prst="rect">
                <a:avLst/>
              </a:prstGeom>
            </p:spPr>
          </p:pic>
          <p:pic>
            <p:nvPicPr>
              <p:cNvPr id="39" name="Рисунок 38">
                <a:extLst>
                  <a:ext uri="{FF2B5EF4-FFF2-40B4-BE49-F238E27FC236}">
                    <a16:creationId xmlns:a16="http://schemas.microsoft.com/office/drawing/2014/main" id="{20F4C06B-96C1-0F9F-E6CE-9764909BE5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13" t="8080" r="4930" b="5912"/>
              <a:stretch/>
            </p:blipFill>
            <p:spPr>
              <a:xfrm>
                <a:off x="2326642" y="2728968"/>
                <a:ext cx="1754503" cy="1508423"/>
              </a:xfrm>
              <a:prstGeom prst="rect">
                <a:avLst/>
              </a:prstGeom>
            </p:spPr>
          </p:pic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3A1034DE-23CD-6A7A-1D9A-2C8BB74D8832}"/>
                  </a:ext>
                </a:extLst>
              </p:cNvPr>
              <p:cNvSpPr txBox="1"/>
              <p:nvPr/>
            </p:nvSpPr>
            <p:spPr>
              <a:xfrm>
                <a:off x="686196" y="2477331"/>
                <a:ext cx="12041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With centrifugation</a:t>
                </a:r>
                <a:endParaRPr lang="ru-RU" sz="1000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13B0A682-4A9A-6C98-5C6F-9AD611CC15C2}"/>
                  </a:ext>
                </a:extLst>
              </p:cNvPr>
              <p:cNvSpPr txBox="1"/>
              <p:nvPr/>
            </p:nvSpPr>
            <p:spPr>
              <a:xfrm>
                <a:off x="2508125" y="2477331"/>
                <a:ext cx="13821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70C0"/>
                    </a:solidFill>
                  </a:rPr>
                  <a:t>Without centrifugation</a:t>
                </a:r>
                <a:endParaRPr lang="ru-RU" sz="1000" dirty="0">
                  <a:solidFill>
                    <a:srgbClr val="0070C0"/>
                  </a:solidFill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04B78A72-3843-94B4-2EDB-92522A497CF3}"/>
                  </a:ext>
                </a:extLst>
              </p:cNvPr>
              <p:cNvSpPr txBox="1"/>
              <p:nvPr/>
            </p:nvSpPr>
            <p:spPr>
              <a:xfrm>
                <a:off x="30976" y="2538886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B</a:t>
                </a:r>
                <a:endParaRPr lang="ru-RU" dirty="0"/>
              </a:p>
            </p:txBody>
          </p:sp>
          <p:grpSp>
            <p:nvGrpSpPr>
              <p:cNvPr id="43" name="Группа 42">
                <a:extLst>
                  <a:ext uri="{FF2B5EF4-FFF2-40B4-BE49-F238E27FC236}">
                    <a16:creationId xmlns:a16="http://schemas.microsoft.com/office/drawing/2014/main" id="{02D036E1-75B2-E651-8297-75E16B3A91E4}"/>
                  </a:ext>
                </a:extLst>
              </p:cNvPr>
              <p:cNvGrpSpPr/>
              <p:nvPr/>
            </p:nvGrpSpPr>
            <p:grpSpPr>
              <a:xfrm rot="16200000">
                <a:off x="-113130" y="3268944"/>
                <a:ext cx="689612" cy="251280"/>
                <a:chOff x="4730097" y="4360975"/>
                <a:chExt cx="689612" cy="251280"/>
              </a:xfrm>
            </p:grpSpPr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27792915-DDB9-1340-7C73-46B38089145B}"/>
                    </a:ext>
                  </a:extLst>
                </p:cNvPr>
                <p:cNvSpPr txBox="1"/>
                <p:nvPr/>
              </p:nvSpPr>
              <p:spPr>
                <a:xfrm>
                  <a:off x="4730097" y="4396811"/>
                  <a:ext cx="68961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Count (x10 )</a:t>
                  </a:r>
                  <a:endParaRPr lang="ru-RU" sz="800" dirty="0"/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111998DB-B482-5130-6645-4F06CE3C62B8}"/>
                    </a:ext>
                  </a:extLst>
                </p:cNvPr>
                <p:cNvSpPr txBox="1"/>
                <p:nvPr/>
              </p:nvSpPr>
              <p:spPr>
                <a:xfrm>
                  <a:off x="5170886" y="4360975"/>
                  <a:ext cx="22313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/>
                    <a:t>7</a:t>
                  </a:r>
                  <a:endParaRPr lang="ru-RU" sz="600" dirty="0"/>
                </a:p>
              </p:txBody>
            </p:sp>
          </p:grp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77C06546-A71D-70B8-8BE8-1EF3CE91F1EC}"/>
                  </a:ext>
                </a:extLst>
              </p:cNvPr>
              <p:cNvSpPr txBox="1"/>
              <p:nvPr/>
            </p:nvSpPr>
            <p:spPr>
              <a:xfrm>
                <a:off x="259355" y="361145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</a:t>
                </a:r>
                <a:endParaRPr lang="ru-RU" sz="800" dirty="0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502E8EE-27E0-0F7B-A336-4C3A5900AC44}"/>
                  </a:ext>
                </a:extLst>
              </p:cNvPr>
              <p:cNvSpPr txBox="1"/>
              <p:nvPr/>
            </p:nvSpPr>
            <p:spPr>
              <a:xfrm>
                <a:off x="259214" y="310399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</a:t>
                </a:r>
                <a:endParaRPr lang="ru-RU" sz="800" dirty="0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B26B07EF-12A8-8CDD-D3BA-4E8C9976225B}"/>
                  </a:ext>
                </a:extLst>
              </p:cNvPr>
              <p:cNvSpPr txBox="1"/>
              <p:nvPr/>
            </p:nvSpPr>
            <p:spPr>
              <a:xfrm>
                <a:off x="2182336" y="338699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</a:t>
                </a:r>
                <a:endParaRPr lang="ru-RU" sz="800" dirty="0"/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0D829807-ABA3-45B0-000B-D25335059EEB}"/>
                  </a:ext>
                </a:extLst>
              </p:cNvPr>
              <p:cNvSpPr txBox="1"/>
              <p:nvPr/>
            </p:nvSpPr>
            <p:spPr>
              <a:xfrm>
                <a:off x="2097940" y="3756321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0,5</a:t>
                </a:r>
                <a:endParaRPr lang="ru-RU" sz="800" dirty="0"/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94BFCB6A-D2F8-5955-A126-7AC181C7F87D}"/>
                  </a:ext>
                </a:extLst>
              </p:cNvPr>
              <p:cNvSpPr txBox="1"/>
              <p:nvPr/>
            </p:nvSpPr>
            <p:spPr>
              <a:xfrm>
                <a:off x="2095099" y="3010174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,5</a:t>
                </a:r>
                <a:endParaRPr lang="ru-RU" sz="800" dirty="0"/>
              </a:p>
            </p:txBody>
          </p:sp>
          <p:sp>
            <p:nvSpPr>
              <p:cNvPr id="49" name="Прямоугольник 48">
                <a:extLst>
                  <a:ext uri="{FF2B5EF4-FFF2-40B4-BE49-F238E27FC236}">
                    <a16:creationId xmlns:a16="http://schemas.microsoft.com/office/drawing/2014/main" id="{050F1DBD-EB4B-6EC8-A6A7-4D0FC27433C9}"/>
                  </a:ext>
                </a:extLst>
              </p:cNvPr>
              <p:cNvSpPr/>
              <p:nvPr/>
            </p:nvSpPr>
            <p:spPr>
              <a:xfrm>
                <a:off x="4112223" y="2802855"/>
                <a:ext cx="116652" cy="105363"/>
              </a:xfrm>
              <a:prstGeom prst="rect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50" name="Прямоугольник 49">
                <a:extLst>
                  <a:ext uri="{FF2B5EF4-FFF2-40B4-BE49-F238E27FC236}">
                    <a16:creationId xmlns:a16="http://schemas.microsoft.com/office/drawing/2014/main" id="{307DA785-14C8-D61F-38DB-D1788697AB21}"/>
                  </a:ext>
                </a:extLst>
              </p:cNvPr>
              <p:cNvSpPr/>
              <p:nvPr/>
            </p:nvSpPr>
            <p:spPr>
              <a:xfrm>
                <a:off x="4112223" y="2970100"/>
                <a:ext cx="116652" cy="105363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51" name="Прямоугольник 50">
                <a:extLst>
                  <a:ext uri="{FF2B5EF4-FFF2-40B4-BE49-F238E27FC236}">
                    <a16:creationId xmlns:a16="http://schemas.microsoft.com/office/drawing/2014/main" id="{6E0176F2-7D6B-5382-E7C1-56B71D178C0F}"/>
                  </a:ext>
                </a:extLst>
              </p:cNvPr>
              <p:cNvSpPr/>
              <p:nvPr/>
            </p:nvSpPr>
            <p:spPr>
              <a:xfrm>
                <a:off x="4112223" y="3139743"/>
                <a:ext cx="116652" cy="105363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D429EE85-2331-25AE-8097-7DBCD2998635}"/>
                  </a:ext>
                </a:extLst>
              </p:cNvPr>
              <p:cNvSpPr txBox="1"/>
              <p:nvPr/>
            </p:nvSpPr>
            <p:spPr>
              <a:xfrm>
                <a:off x="4170549" y="2745171"/>
                <a:ext cx="5229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Frame 1</a:t>
                </a:r>
                <a:endParaRPr lang="ru-RU" sz="800" dirty="0"/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80AC3E4B-9044-AFA9-46AE-A64900612318}"/>
                  </a:ext>
                </a:extLst>
              </p:cNvPr>
              <p:cNvSpPr txBox="1"/>
              <p:nvPr/>
            </p:nvSpPr>
            <p:spPr>
              <a:xfrm>
                <a:off x="4177636" y="2917173"/>
                <a:ext cx="5229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Frame 2</a:t>
                </a:r>
                <a:endParaRPr lang="ru-RU" sz="800" dirty="0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E260DF9-1583-4B8E-F6BA-307D8058DE36}"/>
                  </a:ext>
                </a:extLst>
              </p:cNvPr>
              <p:cNvSpPr txBox="1"/>
              <p:nvPr/>
            </p:nvSpPr>
            <p:spPr>
              <a:xfrm>
                <a:off x="4177636" y="3092497"/>
                <a:ext cx="5229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Frame 3</a:t>
                </a:r>
                <a:endParaRPr lang="ru-RU" sz="800" dirty="0"/>
              </a:p>
            </p:txBody>
          </p:sp>
          <p:sp>
            <p:nvSpPr>
              <p:cNvPr id="55" name="Прямоугольник 54">
                <a:extLst>
                  <a:ext uri="{FF2B5EF4-FFF2-40B4-BE49-F238E27FC236}">
                    <a16:creationId xmlns:a16="http://schemas.microsoft.com/office/drawing/2014/main" id="{354A28AF-2C57-B0E8-CA7F-76C5D7AE6F86}"/>
                  </a:ext>
                </a:extLst>
              </p:cNvPr>
              <p:cNvSpPr/>
              <p:nvPr/>
            </p:nvSpPr>
            <p:spPr>
              <a:xfrm>
                <a:off x="3735442" y="2680138"/>
                <a:ext cx="352790" cy="31394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56" name="Прямоугольник 55">
                <a:extLst>
                  <a:ext uri="{FF2B5EF4-FFF2-40B4-BE49-F238E27FC236}">
                    <a16:creationId xmlns:a16="http://schemas.microsoft.com/office/drawing/2014/main" id="{260164B3-F8D0-733E-FCAD-2EF1AF36903B}"/>
                  </a:ext>
                </a:extLst>
              </p:cNvPr>
              <p:cNvSpPr/>
              <p:nvPr/>
            </p:nvSpPr>
            <p:spPr>
              <a:xfrm>
                <a:off x="1889807" y="2698250"/>
                <a:ext cx="352790" cy="31394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77A68C4E-859C-E502-B593-C30CBBFF04D9}"/>
                  </a:ext>
                </a:extLst>
              </p:cNvPr>
              <p:cNvSpPr txBox="1"/>
              <p:nvPr/>
            </p:nvSpPr>
            <p:spPr>
              <a:xfrm>
                <a:off x="989006" y="4284230"/>
                <a:ext cx="6639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read length</a:t>
                </a:r>
                <a:endParaRPr lang="ru-RU" sz="800" dirty="0"/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F400E423-A7E8-8EAC-7DF5-76862286BD9D}"/>
                  </a:ext>
                </a:extLst>
              </p:cNvPr>
              <p:cNvSpPr txBox="1"/>
              <p:nvPr/>
            </p:nvSpPr>
            <p:spPr>
              <a:xfrm>
                <a:off x="989006" y="4192241"/>
                <a:ext cx="6623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6 27 28 29</a:t>
                </a:r>
                <a:endParaRPr lang="ru-RU" sz="800" dirty="0"/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4EEA6B80-A37A-95C2-8257-AD16AE53B120}"/>
                  </a:ext>
                </a:extLst>
              </p:cNvPr>
              <p:cNvSpPr txBox="1"/>
              <p:nvPr/>
            </p:nvSpPr>
            <p:spPr>
              <a:xfrm>
                <a:off x="2908232" y="4281314"/>
                <a:ext cx="6639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read length</a:t>
                </a:r>
                <a:endParaRPr lang="ru-RU" sz="800" dirty="0"/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96DD2567-076A-30A8-C806-757A1EE1EEB1}"/>
                  </a:ext>
                </a:extLst>
              </p:cNvPr>
              <p:cNvSpPr txBox="1"/>
              <p:nvPr/>
            </p:nvSpPr>
            <p:spPr>
              <a:xfrm>
                <a:off x="2908232" y="4189325"/>
                <a:ext cx="6623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6 27 28 29</a:t>
                </a:r>
                <a:endParaRPr lang="ru-RU" sz="800" dirty="0"/>
              </a:p>
            </p:txBody>
          </p:sp>
        </p:grpSp>
        <p:grpSp>
          <p:nvGrpSpPr>
            <p:cNvPr id="63" name="Группа 62">
              <a:extLst>
                <a:ext uri="{FF2B5EF4-FFF2-40B4-BE49-F238E27FC236}">
                  <a16:creationId xmlns:a16="http://schemas.microsoft.com/office/drawing/2014/main" id="{233FBEA4-6C38-9EF7-EF79-4A60E07914AF}"/>
                </a:ext>
              </a:extLst>
            </p:cNvPr>
            <p:cNvGrpSpPr/>
            <p:nvPr/>
          </p:nvGrpSpPr>
          <p:grpSpPr>
            <a:xfrm>
              <a:off x="0" y="4055410"/>
              <a:ext cx="4123203" cy="1970672"/>
              <a:chOff x="54433" y="4651680"/>
              <a:chExt cx="4123203" cy="1970672"/>
            </a:xfrm>
          </p:grpSpPr>
          <p:pic>
            <p:nvPicPr>
              <p:cNvPr id="64" name="Рисунок 63">
                <a:extLst>
                  <a:ext uri="{FF2B5EF4-FFF2-40B4-BE49-F238E27FC236}">
                    <a16:creationId xmlns:a16="http://schemas.microsoft.com/office/drawing/2014/main" id="{ECAE200D-E8C9-C20F-65E6-A47EAE261D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75" t="6050" r="-1" b="6043"/>
              <a:stretch/>
            </p:blipFill>
            <p:spPr>
              <a:xfrm>
                <a:off x="397878" y="4859721"/>
                <a:ext cx="1884993" cy="1508423"/>
              </a:xfrm>
              <a:prstGeom prst="rect">
                <a:avLst/>
              </a:prstGeom>
            </p:spPr>
          </p:pic>
          <p:pic>
            <p:nvPicPr>
              <p:cNvPr id="65" name="Рисунок 64">
                <a:extLst>
                  <a:ext uri="{FF2B5EF4-FFF2-40B4-BE49-F238E27FC236}">
                    <a16:creationId xmlns:a16="http://schemas.microsoft.com/office/drawing/2014/main" id="{09886A98-423C-EC96-F934-85BAAFDABB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12" t="5516" b="6432"/>
              <a:stretch/>
            </p:blipFill>
            <p:spPr>
              <a:xfrm>
                <a:off x="2326642" y="4948647"/>
                <a:ext cx="1850994" cy="1419497"/>
              </a:xfrm>
              <a:prstGeom prst="rect">
                <a:avLst/>
              </a:prstGeom>
            </p:spPr>
          </p:pic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CBDCA2A0-F923-A49C-9681-2E726E6120E0}"/>
                  </a:ext>
                </a:extLst>
              </p:cNvPr>
              <p:cNvSpPr txBox="1"/>
              <p:nvPr/>
            </p:nvSpPr>
            <p:spPr>
              <a:xfrm>
                <a:off x="54433" y="4651680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</a:t>
                </a:r>
                <a:endParaRPr lang="ru-RU" dirty="0"/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7BB98F6F-E8BA-3E7D-7326-7C911798C6B0}"/>
                  </a:ext>
                </a:extLst>
              </p:cNvPr>
              <p:cNvSpPr txBox="1"/>
              <p:nvPr/>
            </p:nvSpPr>
            <p:spPr>
              <a:xfrm>
                <a:off x="682621" y="4713235"/>
                <a:ext cx="12041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With centrifugation</a:t>
                </a:r>
                <a:endParaRPr lang="ru-RU" sz="1000" dirty="0"/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9A0367C7-7924-3F73-BCEC-15EF41AB1FC5}"/>
                  </a:ext>
                </a:extLst>
              </p:cNvPr>
              <p:cNvSpPr txBox="1"/>
              <p:nvPr/>
            </p:nvSpPr>
            <p:spPr>
              <a:xfrm>
                <a:off x="2554398" y="4718161"/>
                <a:ext cx="13821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70C0"/>
                    </a:solidFill>
                  </a:rPr>
                  <a:t>Without centrifugation</a:t>
                </a:r>
                <a:endParaRPr lang="ru-RU" sz="1000" dirty="0">
                  <a:solidFill>
                    <a:srgbClr val="0070C0"/>
                  </a:solidFill>
                </a:endParaRP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9871CC50-7F88-DF98-1D36-47895780212C}"/>
                  </a:ext>
                </a:extLst>
              </p:cNvPr>
              <p:cNvSpPr txBox="1"/>
              <p:nvPr/>
            </p:nvSpPr>
            <p:spPr>
              <a:xfrm>
                <a:off x="251322" y="590896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</a:t>
                </a:r>
                <a:endParaRPr lang="ru-RU" sz="800" dirty="0"/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A450B52A-BB24-017F-E96C-0796A4FF5D9C}"/>
                  </a:ext>
                </a:extLst>
              </p:cNvPr>
              <p:cNvSpPr txBox="1"/>
              <p:nvPr/>
            </p:nvSpPr>
            <p:spPr>
              <a:xfrm>
                <a:off x="255404" y="5558060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</a:t>
                </a:r>
                <a:endParaRPr lang="ru-RU" sz="800" dirty="0"/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5A97E09-8251-B03A-90D7-A077065DD51C}"/>
                  </a:ext>
                </a:extLst>
              </p:cNvPr>
              <p:cNvSpPr txBox="1"/>
              <p:nvPr/>
            </p:nvSpPr>
            <p:spPr>
              <a:xfrm>
                <a:off x="257185" y="5210629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3</a:t>
                </a:r>
                <a:endParaRPr lang="ru-RU" sz="800" dirty="0"/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3CC91667-D85D-D20D-855A-E55ADC18DEF9}"/>
                  </a:ext>
                </a:extLst>
              </p:cNvPr>
              <p:cNvSpPr txBox="1"/>
              <p:nvPr/>
            </p:nvSpPr>
            <p:spPr>
              <a:xfrm>
                <a:off x="257185" y="4871562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4</a:t>
                </a:r>
                <a:endParaRPr lang="ru-RU" sz="800" dirty="0"/>
              </a:p>
            </p:txBody>
          </p:sp>
          <p:grpSp>
            <p:nvGrpSpPr>
              <p:cNvPr id="73" name="Группа 72">
                <a:extLst>
                  <a:ext uri="{FF2B5EF4-FFF2-40B4-BE49-F238E27FC236}">
                    <a16:creationId xmlns:a16="http://schemas.microsoft.com/office/drawing/2014/main" id="{E382F827-F94E-44E8-E3DC-DE9EF7842416}"/>
                  </a:ext>
                </a:extLst>
              </p:cNvPr>
              <p:cNvGrpSpPr/>
              <p:nvPr/>
            </p:nvGrpSpPr>
            <p:grpSpPr>
              <a:xfrm rot="16200000">
                <a:off x="-129068" y="5504516"/>
                <a:ext cx="689612" cy="251280"/>
                <a:chOff x="4730097" y="4360975"/>
                <a:chExt cx="689612" cy="251280"/>
              </a:xfrm>
            </p:grpSpPr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7A7C273A-C0E4-7003-7C6C-729ABB25E5F7}"/>
                    </a:ext>
                  </a:extLst>
                </p:cNvPr>
                <p:cNvSpPr txBox="1"/>
                <p:nvPr/>
              </p:nvSpPr>
              <p:spPr>
                <a:xfrm>
                  <a:off x="4730097" y="4396811"/>
                  <a:ext cx="68961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Count (x10 )</a:t>
                  </a:r>
                  <a:endParaRPr lang="ru-RU" sz="800" dirty="0"/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8CA74C05-17B5-52F6-829F-EE06D402C56D}"/>
                    </a:ext>
                  </a:extLst>
                </p:cNvPr>
                <p:cNvSpPr txBox="1"/>
                <p:nvPr/>
              </p:nvSpPr>
              <p:spPr>
                <a:xfrm>
                  <a:off x="5170886" y="4360975"/>
                  <a:ext cx="22313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/>
                    <a:t>7</a:t>
                  </a:r>
                  <a:endParaRPr lang="ru-RU" sz="600" dirty="0"/>
                </a:p>
              </p:txBody>
            </p:sp>
          </p:grp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81454247-D449-E762-0973-EF84A34845C2}"/>
                  </a:ext>
                </a:extLst>
              </p:cNvPr>
              <p:cNvSpPr txBox="1"/>
              <p:nvPr/>
            </p:nvSpPr>
            <p:spPr>
              <a:xfrm>
                <a:off x="2171183" y="5865042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</a:t>
                </a:r>
                <a:endParaRPr lang="ru-RU" sz="800" dirty="0"/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48DF8B8A-BA78-9B40-2EFF-48ACAE32D4BF}"/>
                  </a:ext>
                </a:extLst>
              </p:cNvPr>
              <p:cNvSpPr txBox="1"/>
              <p:nvPr/>
            </p:nvSpPr>
            <p:spPr>
              <a:xfrm>
                <a:off x="2172043" y="5475624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</a:t>
                </a:r>
                <a:endParaRPr lang="ru-RU" sz="800" dirty="0"/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E42092FA-6908-18B3-0568-27557C5A4484}"/>
                  </a:ext>
                </a:extLst>
              </p:cNvPr>
              <p:cNvSpPr txBox="1"/>
              <p:nvPr/>
            </p:nvSpPr>
            <p:spPr>
              <a:xfrm>
                <a:off x="2172043" y="5083874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3</a:t>
                </a:r>
                <a:endParaRPr lang="ru-RU" sz="800" dirty="0"/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C9EB0C74-BAC0-B021-BD0C-982869D810DE}"/>
                  </a:ext>
                </a:extLst>
              </p:cNvPr>
              <p:cNvSpPr txBox="1"/>
              <p:nvPr/>
            </p:nvSpPr>
            <p:spPr>
              <a:xfrm>
                <a:off x="989006" y="6406908"/>
                <a:ext cx="6639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read length</a:t>
                </a:r>
                <a:endParaRPr lang="ru-RU" sz="800" dirty="0"/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4115E35E-6778-12D4-DAB7-5DB667011369}"/>
                  </a:ext>
                </a:extLst>
              </p:cNvPr>
              <p:cNvSpPr txBox="1"/>
              <p:nvPr/>
            </p:nvSpPr>
            <p:spPr>
              <a:xfrm>
                <a:off x="989006" y="6314919"/>
                <a:ext cx="6623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6 27 28 29</a:t>
                </a:r>
                <a:endParaRPr lang="ru-RU" sz="800" dirty="0"/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7F1C30B4-62A9-F9A4-038B-8F360E5A3BD0}"/>
                  </a:ext>
                </a:extLst>
              </p:cNvPr>
              <p:cNvSpPr txBox="1"/>
              <p:nvPr/>
            </p:nvSpPr>
            <p:spPr>
              <a:xfrm>
                <a:off x="2908232" y="6406908"/>
                <a:ext cx="6639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read length</a:t>
                </a:r>
                <a:endParaRPr lang="ru-RU" sz="800" dirty="0"/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8C043C2D-2370-F274-36DB-07547D81AE13}"/>
                  </a:ext>
                </a:extLst>
              </p:cNvPr>
              <p:cNvSpPr txBox="1"/>
              <p:nvPr/>
            </p:nvSpPr>
            <p:spPr>
              <a:xfrm>
                <a:off x="2908232" y="6314919"/>
                <a:ext cx="6623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6 27 28 29</a:t>
                </a:r>
                <a:endParaRPr lang="ru-RU" sz="800" dirty="0"/>
              </a:p>
            </p:txBody>
          </p:sp>
        </p:grpSp>
        <p:pic>
          <p:nvPicPr>
            <p:cNvPr id="84" name="Рисунок 83">
              <a:extLst>
                <a:ext uri="{FF2B5EF4-FFF2-40B4-BE49-F238E27FC236}">
                  <a16:creationId xmlns:a16="http://schemas.microsoft.com/office/drawing/2014/main" id="{359F1845-5496-4053-CB3C-2F50BA83634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2" t="4589" b="11035"/>
            <a:stretch/>
          </p:blipFill>
          <p:spPr>
            <a:xfrm>
              <a:off x="331487" y="6511278"/>
              <a:ext cx="2830861" cy="1338838"/>
            </a:xfrm>
            <a:prstGeom prst="rect">
              <a:avLst/>
            </a:prstGeom>
          </p:spPr>
        </p:pic>
        <p:pic>
          <p:nvPicPr>
            <p:cNvPr id="85" name="Рисунок 84">
              <a:extLst>
                <a:ext uri="{FF2B5EF4-FFF2-40B4-BE49-F238E27FC236}">
                  <a16:creationId xmlns:a16="http://schemas.microsoft.com/office/drawing/2014/main" id="{A2EAA47A-5EB1-CE1B-281D-13E61695D56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2" t="4589" b="11186"/>
            <a:stretch/>
          </p:blipFill>
          <p:spPr>
            <a:xfrm>
              <a:off x="3482157" y="6498867"/>
              <a:ext cx="2830862" cy="1351250"/>
            </a:xfrm>
            <a:prstGeom prst="rect">
              <a:avLst/>
            </a:prstGeom>
          </p:spPr>
        </p:pic>
        <p:cxnSp>
          <p:nvCxnSpPr>
            <p:cNvPr id="86" name="Прямая со стрелкой 85">
              <a:extLst>
                <a:ext uri="{FF2B5EF4-FFF2-40B4-BE49-F238E27FC236}">
                  <a16:creationId xmlns:a16="http://schemas.microsoft.com/office/drawing/2014/main" id="{25105124-58AB-0F09-8B07-251B15D956B3}"/>
                </a:ext>
              </a:extLst>
            </p:cNvPr>
            <p:cNvCxnSpPr>
              <a:cxnSpLocks/>
              <a:stCxn id="87" idx="3"/>
            </p:cNvCxnSpPr>
            <p:nvPr/>
          </p:nvCxnSpPr>
          <p:spPr>
            <a:xfrm>
              <a:off x="4685717" y="6436360"/>
              <a:ext cx="161208" cy="13489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7B01B0FD-137A-7277-B684-C463327E16B0}"/>
                </a:ext>
              </a:extLst>
            </p:cNvPr>
            <p:cNvSpPr txBox="1"/>
            <p:nvPr/>
          </p:nvSpPr>
          <p:spPr>
            <a:xfrm>
              <a:off x="4372811" y="6328638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5</a:t>
              </a:r>
              <a:endParaRPr lang="ru-RU" sz="800" dirty="0"/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42F5308F-C6A4-E59C-D248-16678435D19A}"/>
                </a:ext>
              </a:extLst>
            </p:cNvPr>
            <p:cNvSpPr txBox="1"/>
            <p:nvPr/>
          </p:nvSpPr>
          <p:spPr>
            <a:xfrm>
              <a:off x="1096212" y="6167949"/>
              <a:ext cx="12041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With centrifugation</a:t>
              </a:r>
              <a:endParaRPr lang="ru-RU" sz="1000" dirty="0"/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CC9E94CF-D02F-020F-E14B-A5630DE47863}"/>
                </a:ext>
              </a:extLst>
            </p:cNvPr>
            <p:cNvSpPr txBox="1"/>
            <p:nvPr/>
          </p:nvSpPr>
          <p:spPr>
            <a:xfrm>
              <a:off x="4143629" y="6172075"/>
              <a:ext cx="13821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0070C0"/>
                  </a:solidFill>
                </a:rPr>
                <a:t>Without centrifugation</a:t>
              </a:r>
              <a:endParaRPr lang="ru-RU" sz="1000" dirty="0">
                <a:solidFill>
                  <a:srgbClr val="0070C0"/>
                </a:solidFill>
              </a:endParaRPr>
            </a:p>
          </p:txBody>
        </p:sp>
        <p:sp>
          <p:nvSpPr>
            <p:cNvPr id="90" name="Прямоугольник 89">
              <a:extLst>
                <a:ext uri="{FF2B5EF4-FFF2-40B4-BE49-F238E27FC236}">
                  <a16:creationId xmlns:a16="http://schemas.microsoft.com/office/drawing/2014/main" id="{B812158A-5018-8E89-50AC-F7B04CEBF834}"/>
                </a:ext>
              </a:extLst>
            </p:cNvPr>
            <p:cNvSpPr/>
            <p:nvPr/>
          </p:nvSpPr>
          <p:spPr>
            <a:xfrm>
              <a:off x="2559246" y="6511369"/>
              <a:ext cx="518202" cy="2990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91" name="Прямоугольник 90">
              <a:extLst>
                <a:ext uri="{FF2B5EF4-FFF2-40B4-BE49-F238E27FC236}">
                  <a16:creationId xmlns:a16="http://schemas.microsoft.com/office/drawing/2014/main" id="{6B85260F-7AFD-05A3-180A-044E16A72895}"/>
                </a:ext>
              </a:extLst>
            </p:cNvPr>
            <p:cNvSpPr/>
            <p:nvPr/>
          </p:nvSpPr>
          <p:spPr>
            <a:xfrm>
              <a:off x="5737578" y="6484224"/>
              <a:ext cx="518202" cy="2990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608870F5-9F66-9723-2A01-F6ABE2A444A3}"/>
                </a:ext>
              </a:extLst>
            </p:cNvPr>
            <p:cNvSpPr txBox="1"/>
            <p:nvPr/>
          </p:nvSpPr>
          <p:spPr>
            <a:xfrm>
              <a:off x="1488087" y="7860419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tart</a:t>
              </a:r>
              <a:endParaRPr lang="ru-RU" sz="1000" dirty="0"/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F48B9DC4-E726-17A1-889C-2F418B7ED9BB}"/>
                </a:ext>
              </a:extLst>
            </p:cNvPr>
            <p:cNvSpPr txBox="1"/>
            <p:nvPr/>
          </p:nvSpPr>
          <p:spPr>
            <a:xfrm>
              <a:off x="4680439" y="7866728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tart</a:t>
              </a:r>
              <a:endParaRPr lang="ru-RU" sz="1000" dirty="0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118D08FD-A12B-A202-87AF-BFDB58F4A386}"/>
                </a:ext>
              </a:extLst>
            </p:cNvPr>
            <p:cNvSpPr txBox="1"/>
            <p:nvPr/>
          </p:nvSpPr>
          <p:spPr>
            <a:xfrm>
              <a:off x="1591898" y="779408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</a:t>
              </a:r>
              <a:endParaRPr lang="ru-RU" sz="800" dirty="0"/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C5BFD26F-28E3-F4DF-8BA2-F8B219A0153B}"/>
                </a:ext>
              </a:extLst>
            </p:cNvPr>
            <p:cNvSpPr txBox="1"/>
            <p:nvPr/>
          </p:nvSpPr>
          <p:spPr>
            <a:xfrm>
              <a:off x="1048075" y="7795156"/>
              <a:ext cx="3706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-100</a:t>
              </a:r>
              <a:endParaRPr lang="ru-RU" sz="800" dirty="0"/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A2C4EEDA-F745-3AB8-1F73-2A3493700CBB}"/>
                </a:ext>
              </a:extLst>
            </p:cNvPr>
            <p:cNvSpPr txBox="1"/>
            <p:nvPr/>
          </p:nvSpPr>
          <p:spPr>
            <a:xfrm>
              <a:off x="604803" y="7794088"/>
              <a:ext cx="3706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-200</a:t>
              </a:r>
              <a:endParaRPr lang="ru-RU" sz="800" dirty="0"/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8AFCA21C-4517-B7F6-A449-80C9BDEF008A}"/>
                </a:ext>
              </a:extLst>
            </p:cNvPr>
            <p:cNvSpPr txBox="1"/>
            <p:nvPr/>
          </p:nvSpPr>
          <p:spPr>
            <a:xfrm>
              <a:off x="147585" y="7793845"/>
              <a:ext cx="3706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-300</a:t>
              </a:r>
              <a:endParaRPr lang="ru-RU" sz="800" dirty="0"/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788F1670-2011-5358-60B2-71349D92C8A8}"/>
                </a:ext>
              </a:extLst>
            </p:cNvPr>
            <p:cNvSpPr txBox="1"/>
            <p:nvPr/>
          </p:nvSpPr>
          <p:spPr>
            <a:xfrm>
              <a:off x="2000110" y="779538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00</a:t>
              </a:r>
              <a:endParaRPr lang="ru-RU" sz="800" dirty="0"/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142C8671-45ED-4181-02A9-062C8E43190B}"/>
                </a:ext>
              </a:extLst>
            </p:cNvPr>
            <p:cNvSpPr txBox="1"/>
            <p:nvPr/>
          </p:nvSpPr>
          <p:spPr>
            <a:xfrm>
              <a:off x="2457328" y="779322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00</a:t>
              </a:r>
              <a:endParaRPr lang="ru-RU" sz="800" dirty="0"/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AA663BA4-144F-CAFB-2C6B-83B510D2FE0E}"/>
                </a:ext>
              </a:extLst>
            </p:cNvPr>
            <p:cNvSpPr txBox="1"/>
            <p:nvPr/>
          </p:nvSpPr>
          <p:spPr>
            <a:xfrm>
              <a:off x="2918301" y="778896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00</a:t>
              </a:r>
              <a:endParaRPr lang="ru-RU" sz="800" dirty="0"/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906682A0-A407-B3A1-DAF2-059964D3C373}"/>
                </a:ext>
              </a:extLst>
            </p:cNvPr>
            <p:cNvSpPr txBox="1"/>
            <p:nvPr/>
          </p:nvSpPr>
          <p:spPr>
            <a:xfrm rot="16200000">
              <a:off x="-481212" y="6851992"/>
              <a:ext cx="12971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Average read density (x10)</a:t>
              </a:r>
              <a:endParaRPr lang="ru-RU" sz="800" dirty="0"/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2E6389D3-5D31-0D21-71BE-90B5ADE096A0}"/>
                </a:ext>
              </a:extLst>
            </p:cNvPr>
            <p:cNvSpPr txBox="1"/>
            <p:nvPr/>
          </p:nvSpPr>
          <p:spPr>
            <a:xfrm>
              <a:off x="159793" y="7066770"/>
              <a:ext cx="2359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</a:t>
              </a:r>
              <a:endParaRPr lang="ru-RU" sz="800" dirty="0"/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E573BFFE-3D67-EC04-7D58-3492DE9E7DAE}"/>
                </a:ext>
              </a:extLst>
            </p:cNvPr>
            <p:cNvSpPr txBox="1"/>
            <p:nvPr/>
          </p:nvSpPr>
          <p:spPr>
            <a:xfrm>
              <a:off x="170279" y="646210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</a:t>
              </a:r>
              <a:endParaRPr lang="ru-RU" sz="800" dirty="0"/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0EBD59CD-F224-7BB3-8222-C88B84B16652}"/>
                </a:ext>
              </a:extLst>
            </p:cNvPr>
            <p:cNvSpPr txBox="1"/>
            <p:nvPr/>
          </p:nvSpPr>
          <p:spPr>
            <a:xfrm>
              <a:off x="3315797" y="707435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</a:t>
              </a:r>
              <a:endParaRPr lang="ru-RU" sz="800" dirty="0"/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F20FCFE2-1546-EBE2-7385-DB7BD2CD10C1}"/>
                </a:ext>
              </a:extLst>
            </p:cNvPr>
            <p:cNvSpPr txBox="1"/>
            <p:nvPr/>
          </p:nvSpPr>
          <p:spPr>
            <a:xfrm>
              <a:off x="3311019" y="641831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</a:t>
              </a:r>
              <a:endParaRPr lang="ru-RU" sz="800" dirty="0"/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269CA001-8A2F-3C85-E0F7-B600972B4273}"/>
                </a:ext>
              </a:extLst>
            </p:cNvPr>
            <p:cNvSpPr txBox="1"/>
            <p:nvPr/>
          </p:nvSpPr>
          <p:spPr>
            <a:xfrm>
              <a:off x="4760110" y="781003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</a:t>
              </a:r>
              <a:endParaRPr lang="ru-RU" sz="800" dirty="0"/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CE48B181-057E-ED39-1B3F-924D94084E82}"/>
                </a:ext>
              </a:extLst>
            </p:cNvPr>
            <p:cNvSpPr txBox="1"/>
            <p:nvPr/>
          </p:nvSpPr>
          <p:spPr>
            <a:xfrm>
              <a:off x="4216287" y="7811098"/>
              <a:ext cx="3706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-100</a:t>
              </a:r>
              <a:endParaRPr lang="ru-RU" sz="800" dirty="0"/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1847C1B5-BB29-5036-6FCF-26CA137BA8A0}"/>
                </a:ext>
              </a:extLst>
            </p:cNvPr>
            <p:cNvSpPr txBox="1"/>
            <p:nvPr/>
          </p:nvSpPr>
          <p:spPr>
            <a:xfrm>
              <a:off x="3773015" y="7810030"/>
              <a:ext cx="3706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-200</a:t>
              </a:r>
              <a:endParaRPr lang="ru-RU" sz="800" dirty="0"/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9FD17D92-7142-1D2C-B757-7C12E6F30B9A}"/>
                </a:ext>
              </a:extLst>
            </p:cNvPr>
            <p:cNvSpPr txBox="1"/>
            <p:nvPr/>
          </p:nvSpPr>
          <p:spPr>
            <a:xfrm>
              <a:off x="3315797" y="7809787"/>
              <a:ext cx="3706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-300</a:t>
              </a:r>
              <a:endParaRPr lang="ru-RU" sz="800" dirty="0"/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C97B712B-C8F9-6C13-74B8-1094E3C888BA}"/>
                </a:ext>
              </a:extLst>
            </p:cNvPr>
            <p:cNvSpPr txBox="1"/>
            <p:nvPr/>
          </p:nvSpPr>
          <p:spPr>
            <a:xfrm>
              <a:off x="5168322" y="781132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00</a:t>
              </a:r>
              <a:endParaRPr lang="ru-RU" sz="800" dirty="0"/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1637E313-57E5-8A3A-C416-331B7B8D307D}"/>
                </a:ext>
              </a:extLst>
            </p:cNvPr>
            <p:cNvSpPr txBox="1"/>
            <p:nvPr/>
          </p:nvSpPr>
          <p:spPr>
            <a:xfrm>
              <a:off x="5625540" y="780916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00</a:t>
              </a:r>
              <a:endParaRPr lang="ru-RU" sz="800" dirty="0"/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D1F2D991-97F6-9228-EFEB-0BDC9B00E62A}"/>
                </a:ext>
              </a:extLst>
            </p:cNvPr>
            <p:cNvSpPr txBox="1"/>
            <p:nvPr/>
          </p:nvSpPr>
          <p:spPr>
            <a:xfrm>
              <a:off x="6086513" y="780490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00</a:t>
              </a:r>
              <a:endParaRPr lang="ru-RU" sz="800" dirty="0"/>
            </a:p>
          </p:txBody>
        </p:sp>
        <p:grpSp>
          <p:nvGrpSpPr>
            <p:cNvPr id="146" name="Группа 145">
              <a:extLst>
                <a:ext uri="{FF2B5EF4-FFF2-40B4-BE49-F238E27FC236}">
                  <a16:creationId xmlns:a16="http://schemas.microsoft.com/office/drawing/2014/main" id="{96CBF72A-D10A-DD73-DA8F-7D5DEDF44E22}"/>
                </a:ext>
              </a:extLst>
            </p:cNvPr>
            <p:cNvGrpSpPr/>
            <p:nvPr/>
          </p:nvGrpSpPr>
          <p:grpSpPr>
            <a:xfrm>
              <a:off x="98590" y="8007980"/>
              <a:ext cx="6334079" cy="1916325"/>
              <a:chOff x="74535" y="8311980"/>
              <a:chExt cx="6334079" cy="1916325"/>
            </a:xfrm>
          </p:grpSpPr>
          <p:pic>
            <p:nvPicPr>
              <p:cNvPr id="94" name="Рисунок 93">
                <a:extLst>
                  <a:ext uri="{FF2B5EF4-FFF2-40B4-BE49-F238E27FC236}">
                    <a16:creationId xmlns:a16="http://schemas.microsoft.com/office/drawing/2014/main" id="{768C38E1-069B-C8BD-1D7E-EAC3782F919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40" t="5960" b="15427"/>
              <a:stretch/>
            </p:blipFill>
            <p:spPr>
              <a:xfrm>
                <a:off x="331487" y="8587336"/>
                <a:ext cx="2855452" cy="1338838"/>
              </a:xfrm>
              <a:prstGeom prst="rect">
                <a:avLst/>
              </a:prstGeom>
            </p:spPr>
          </p:pic>
          <p:sp>
            <p:nvSpPr>
              <p:cNvPr id="95" name="Прямоугольник 94">
                <a:extLst>
                  <a:ext uri="{FF2B5EF4-FFF2-40B4-BE49-F238E27FC236}">
                    <a16:creationId xmlns:a16="http://schemas.microsoft.com/office/drawing/2014/main" id="{DA6E8F76-E4B3-95F2-0B0A-43FA4A08316F}"/>
                  </a:ext>
                </a:extLst>
              </p:cNvPr>
              <p:cNvSpPr/>
              <p:nvPr/>
            </p:nvSpPr>
            <p:spPr>
              <a:xfrm>
                <a:off x="2627693" y="8557045"/>
                <a:ext cx="518202" cy="2990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pic>
            <p:nvPicPr>
              <p:cNvPr id="96" name="Рисунок 95">
                <a:extLst>
                  <a:ext uri="{FF2B5EF4-FFF2-40B4-BE49-F238E27FC236}">
                    <a16:creationId xmlns:a16="http://schemas.microsoft.com/office/drawing/2014/main" id="{30B18463-7280-5CCD-CBD1-680BE7ECEA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40" t="5960" b="15427"/>
              <a:stretch/>
            </p:blipFill>
            <p:spPr>
              <a:xfrm>
                <a:off x="3478728" y="8570344"/>
                <a:ext cx="2855453" cy="1355830"/>
              </a:xfrm>
              <a:prstGeom prst="rect">
                <a:avLst/>
              </a:prstGeom>
            </p:spPr>
          </p:pic>
          <p:sp>
            <p:nvSpPr>
              <p:cNvPr id="97" name="Прямоугольник 96">
                <a:extLst>
                  <a:ext uri="{FF2B5EF4-FFF2-40B4-BE49-F238E27FC236}">
                    <a16:creationId xmlns:a16="http://schemas.microsoft.com/office/drawing/2014/main" id="{075961DC-6390-0778-86C3-38F39F90DD54}"/>
                  </a:ext>
                </a:extLst>
              </p:cNvPr>
              <p:cNvSpPr/>
              <p:nvPr/>
            </p:nvSpPr>
            <p:spPr>
              <a:xfrm>
                <a:off x="5810959" y="8450596"/>
                <a:ext cx="518202" cy="2990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3FED1D71-1B46-CA2A-4D79-0DB2AD8F38B4}"/>
                  </a:ext>
                </a:extLst>
              </p:cNvPr>
              <p:cNvSpPr txBox="1"/>
              <p:nvPr/>
            </p:nvSpPr>
            <p:spPr>
              <a:xfrm>
                <a:off x="1118035" y="8311980"/>
                <a:ext cx="12041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With centrifugation</a:t>
                </a:r>
                <a:endParaRPr lang="ru-RU" sz="1000" dirty="0"/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ADA49F4C-9B6C-0925-3A05-68248C63E417}"/>
                  </a:ext>
                </a:extLst>
              </p:cNvPr>
              <p:cNvSpPr txBox="1"/>
              <p:nvPr/>
            </p:nvSpPr>
            <p:spPr>
              <a:xfrm>
                <a:off x="4170583" y="8364344"/>
                <a:ext cx="13821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0070C0"/>
                    </a:solidFill>
                  </a:rPr>
                  <a:t>Without centrifugation</a:t>
                </a:r>
                <a:endParaRPr lang="ru-RU" sz="1000" dirty="0">
                  <a:solidFill>
                    <a:srgbClr val="0070C0"/>
                  </a:solidFill>
                </a:endParaRP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2C96053F-ECF9-95F4-428A-D5CAAA8508C9}"/>
                  </a:ext>
                </a:extLst>
              </p:cNvPr>
              <p:cNvSpPr txBox="1"/>
              <p:nvPr/>
            </p:nvSpPr>
            <p:spPr>
              <a:xfrm>
                <a:off x="172418" y="9524513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</a:t>
                </a:r>
                <a:endParaRPr lang="ru-RU" sz="800" dirty="0"/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2E3D8161-F7EF-1273-C6AF-63400544548E}"/>
                  </a:ext>
                </a:extLst>
              </p:cNvPr>
              <p:cNvSpPr txBox="1"/>
              <p:nvPr/>
            </p:nvSpPr>
            <p:spPr>
              <a:xfrm>
                <a:off x="175784" y="9248973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4</a:t>
                </a:r>
                <a:endParaRPr lang="ru-RU" sz="800" dirty="0"/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06AFACF0-E549-FD20-EDAF-13FCCE7903AF}"/>
                  </a:ext>
                </a:extLst>
              </p:cNvPr>
              <p:cNvSpPr txBox="1"/>
              <p:nvPr/>
            </p:nvSpPr>
            <p:spPr>
              <a:xfrm>
                <a:off x="172144" y="8964157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6</a:t>
                </a:r>
                <a:endParaRPr lang="ru-RU" sz="800" dirty="0"/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22D6BC96-FDD5-3475-7C33-E5B71762F565}"/>
                  </a:ext>
                </a:extLst>
              </p:cNvPr>
              <p:cNvSpPr txBox="1"/>
              <p:nvPr/>
            </p:nvSpPr>
            <p:spPr>
              <a:xfrm>
                <a:off x="172144" y="867839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8</a:t>
                </a:r>
                <a:endParaRPr lang="ru-RU" sz="800" dirty="0"/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91F2482C-75DB-352F-47AE-0E321F53A40F}"/>
                  </a:ext>
                </a:extLst>
              </p:cNvPr>
              <p:cNvSpPr txBox="1"/>
              <p:nvPr/>
            </p:nvSpPr>
            <p:spPr>
              <a:xfrm rot="16200000">
                <a:off x="-466318" y="9022528"/>
                <a:ext cx="12971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verage read density (x10)</a:t>
                </a:r>
                <a:endParaRPr lang="ru-RU" sz="800" dirty="0"/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CC4E4DDF-6F56-0058-4025-12BF3BB89F64}"/>
                  </a:ext>
                </a:extLst>
              </p:cNvPr>
              <p:cNvSpPr txBox="1"/>
              <p:nvPr/>
            </p:nvSpPr>
            <p:spPr>
              <a:xfrm>
                <a:off x="1499125" y="9970164"/>
                <a:ext cx="4219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Stop</a:t>
                </a:r>
                <a:endParaRPr lang="ru-RU" sz="1000" dirty="0"/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EE2C55D1-C579-FD7B-1921-ADBD3390E533}"/>
                  </a:ext>
                </a:extLst>
              </p:cNvPr>
              <p:cNvSpPr txBox="1"/>
              <p:nvPr/>
            </p:nvSpPr>
            <p:spPr>
              <a:xfrm>
                <a:off x="1602936" y="9903833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0</a:t>
                </a:r>
                <a:endParaRPr lang="ru-RU" sz="800" dirty="0"/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8C2B5ED6-BE1C-87A0-8B54-49AEA02E53EC}"/>
                  </a:ext>
                </a:extLst>
              </p:cNvPr>
              <p:cNvSpPr txBox="1"/>
              <p:nvPr/>
            </p:nvSpPr>
            <p:spPr>
              <a:xfrm>
                <a:off x="1059113" y="9904901"/>
                <a:ext cx="3706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-100</a:t>
                </a:r>
                <a:endParaRPr lang="ru-RU" sz="800" dirty="0"/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F485E2F8-E449-76CE-068D-CE839A96865F}"/>
                  </a:ext>
                </a:extLst>
              </p:cNvPr>
              <p:cNvSpPr txBox="1"/>
              <p:nvPr/>
            </p:nvSpPr>
            <p:spPr>
              <a:xfrm>
                <a:off x="615841" y="9903833"/>
                <a:ext cx="3706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-200</a:t>
                </a:r>
                <a:endParaRPr lang="ru-RU" sz="800" dirty="0"/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4004BB98-3233-7CB2-0ECB-00779EE03B0F}"/>
                  </a:ext>
                </a:extLst>
              </p:cNvPr>
              <p:cNvSpPr txBox="1"/>
              <p:nvPr/>
            </p:nvSpPr>
            <p:spPr>
              <a:xfrm>
                <a:off x="158623" y="9903590"/>
                <a:ext cx="3706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-300</a:t>
                </a:r>
                <a:endParaRPr lang="ru-RU" sz="800" dirty="0"/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5A24DB52-3F03-9BC7-C9FE-BF9A5C74D0CA}"/>
                  </a:ext>
                </a:extLst>
              </p:cNvPr>
              <p:cNvSpPr txBox="1"/>
              <p:nvPr/>
            </p:nvSpPr>
            <p:spPr>
              <a:xfrm>
                <a:off x="2011148" y="990512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00</a:t>
                </a:r>
                <a:endParaRPr lang="ru-RU" sz="800" dirty="0"/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60C5178D-06EC-6CF7-267A-7A4F73F84624}"/>
                  </a:ext>
                </a:extLst>
              </p:cNvPr>
              <p:cNvSpPr txBox="1"/>
              <p:nvPr/>
            </p:nvSpPr>
            <p:spPr>
              <a:xfrm>
                <a:off x="2468366" y="990296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00</a:t>
                </a:r>
                <a:endParaRPr lang="ru-RU" sz="800" dirty="0"/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11449EBF-DB83-144B-AE27-BDB6B4A4094E}"/>
                  </a:ext>
                </a:extLst>
              </p:cNvPr>
              <p:cNvSpPr txBox="1"/>
              <p:nvPr/>
            </p:nvSpPr>
            <p:spPr>
              <a:xfrm>
                <a:off x="2929339" y="989870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300</a:t>
                </a:r>
                <a:endParaRPr lang="ru-RU" sz="800" dirty="0"/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19BFC1DD-2EE9-C1BF-4FA8-4B30F3EF22A0}"/>
                  </a:ext>
                </a:extLst>
              </p:cNvPr>
              <p:cNvSpPr txBox="1"/>
              <p:nvPr/>
            </p:nvSpPr>
            <p:spPr>
              <a:xfrm>
                <a:off x="3320434" y="948812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</a:t>
                </a:r>
                <a:endParaRPr lang="ru-RU" sz="800" dirty="0"/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3633BB31-D66B-68E3-CFD0-A54E7C8FA573}"/>
                  </a:ext>
                </a:extLst>
              </p:cNvPr>
              <p:cNvSpPr txBox="1"/>
              <p:nvPr/>
            </p:nvSpPr>
            <p:spPr>
              <a:xfrm>
                <a:off x="3324890" y="917197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4</a:t>
                </a:r>
                <a:endParaRPr lang="ru-RU" sz="800" dirty="0"/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6ABB8A30-EE02-D200-6E78-F6CC9066D47C}"/>
                  </a:ext>
                </a:extLst>
              </p:cNvPr>
              <p:cNvSpPr txBox="1"/>
              <p:nvPr/>
            </p:nvSpPr>
            <p:spPr>
              <a:xfrm>
                <a:off x="3318030" y="8837119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6</a:t>
                </a:r>
                <a:endParaRPr lang="ru-RU" sz="800" dirty="0"/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561DDA3A-B0BB-A65E-5011-34646E7730E9}"/>
                  </a:ext>
                </a:extLst>
              </p:cNvPr>
              <p:cNvSpPr txBox="1"/>
              <p:nvPr/>
            </p:nvSpPr>
            <p:spPr>
              <a:xfrm>
                <a:off x="3318030" y="8504069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8</a:t>
                </a:r>
                <a:endParaRPr lang="ru-RU" sz="800" dirty="0"/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DD76DC9D-35A8-EEE2-7C71-6998D7931995}"/>
                  </a:ext>
                </a:extLst>
              </p:cNvPr>
              <p:cNvSpPr txBox="1"/>
              <p:nvPr/>
            </p:nvSpPr>
            <p:spPr>
              <a:xfrm>
                <a:off x="4639846" y="9982084"/>
                <a:ext cx="4219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Stop</a:t>
                </a:r>
                <a:endParaRPr lang="ru-RU" sz="1000" dirty="0"/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890B0B87-1F49-4869-8629-A33B5A2CE7A2}"/>
                  </a:ext>
                </a:extLst>
              </p:cNvPr>
              <p:cNvSpPr txBox="1"/>
              <p:nvPr/>
            </p:nvSpPr>
            <p:spPr>
              <a:xfrm>
                <a:off x="4743657" y="9915753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0</a:t>
                </a:r>
                <a:endParaRPr lang="ru-RU" sz="800" dirty="0"/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43F8CE48-6D64-5B6B-110E-CE5F02306AB9}"/>
                  </a:ext>
                </a:extLst>
              </p:cNvPr>
              <p:cNvSpPr txBox="1"/>
              <p:nvPr/>
            </p:nvSpPr>
            <p:spPr>
              <a:xfrm>
                <a:off x="4199834" y="9916821"/>
                <a:ext cx="3706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-100</a:t>
                </a:r>
                <a:endParaRPr lang="ru-RU" sz="800" dirty="0"/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5EA09B5F-145C-EFB9-63F5-CB6E6E23D785}"/>
                  </a:ext>
                </a:extLst>
              </p:cNvPr>
              <p:cNvSpPr txBox="1"/>
              <p:nvPr/>
            </p:nvSpPr>
            <p:spPr>
              <a:xfrm>
                <a:off x="3756562" y="9915753"/>
                <a:ext cx="3706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-200</a:t>
                </a:r>
                <a:endParaRPr lang="ru-RU" sz="800" dirty="0"/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1A3D4352-9EC7-0FB0-CA5A-335DF6FA34C6}"/>
                  </a:ext>
                </a:extLst>
              </p:cNvPr>
              <p:cNvSpPr txBox="1"/>
              <p:nvPr/>
            </p:nvSpPr>
            <p:spPr>
              <a:xfrm>
                <a:off x="3299344" y="9915510"/>
                <a:ext cx="3706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-300</a:t>
                </a:r>
                <a:endParaRPr lang="ru-RU" sz="800" dirty="0"/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6454A79B-4E49-E6B4-D079-9CDD51F634D1}"/>
                  </a:ext>
                </a:extLst>
              </p:cNvPr>
              <p:cNvSpPr txBox="1"/>
              <p:nvPr/>
            </p:nvSpPr>
            <p:spPr>
              <a:xfrm>
                <a:off x="5151869" y="991704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00</a:t>
                </a:r>
                <a:endParaRPr lang="ru-RU" sz="800" dirty="0"/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79F4511A-122A-0F3D-A041-19C6A16AFB46}"/>
                  </a:ext>
                </a:extLst>
              </p:cNvPr>
              <p:cNvSpPr txBox="1"/>
              <p:nvPr/>
            </p:nvSpPr>
            <p:spPr>
              <a:xfrm>
                <a:off x="5609087" y="991488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00</a:t>
                </a:r>
                <a:endParaRPr lang="ru-RU" sz="800" dirty="0"/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14F9B474-E2E7-2CA8-A672-12803E0893A3}"/>
                  </a:ext>
                </a:extLst>
              </p:cNvPr>
              <p:cNvSpPr txBox="1"/>
              <p:nvPr/>
            </p:nvSpPr>
            <p:spPr>
              <a:xfrm>
                <a:off x="6070060" y="991062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300</a:t>
                </a:r>
                <a:endParaRPr lang="ru-RU" sz="800" dirty="0"/>
              </a:p>
            </p:txBody>
          </p:sp>
        </p:grp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7D42C776-34AD-13F1-CA2A-85A5016B5D09}"/>
                </a:ext>
              </a:extLst>
            </p:cNvPr>
            <p:cNvSpPr txBox="1"/>
            <p:nvPr/>
          </p:nvSpPr>
          <p:spPr>
            <a:xfrm>
              <a:off x="0" y="5940917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</a:t>
              </a:r>
              <a:endParaRPr lang="ru-RU" dirty="0"/>
            </a:p>
          </p:txBody>
        </p:sp>
      </p:grpSp>
    </p:spTree>
    <p:extLst>
      <p:ext uri="{BB962C8B-B14F-4D97-AF65-F5344CB8AC3E}">
        <p14:creationId xmlns:p14="http://schemas.microsoft.com/office/powerpoint/2010/main" val="223116193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</TotalTime>
  <Words>167</Words>
  <Application>Microsoft Office PowerPoint</Application>
  <PresentationFormat>Лист A4 (210x297 мм)</PresentationFormat>
  <Paragraphs>110</Paragraphs>
  <Slides>1</Slides>
  <Notes>1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mitry Andreev</dc:creator>
  <cp:lastModifiedBy>Dmitry Andreev</cp:lastModifiedBy>
  <cp:revision>1</cp:revision>
  <dcterms:created xsi:type="dcterms:W3CDTF">2025-03-02T21:59:14Z</dcterms:created>
  <dcterms:modified xsi:type="dcterms:W3CDTF">2025-03-02T22:08:43Z</dcterms:modified>
</cp:coreProperties>
</file>